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1A916-FEE4-4868-B368-C0FF3DE227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CD4BA-EC53-46CC-901E-1383B1EC4C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3A2BE-541E-4334-A4A3-9F533A923C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A006E-E301-4A44-81B1-508E8C450A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D9E67-FA52-478C-8428-C6D54D4130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9C0BE-E67A-404C-893B-666D26910C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373AA-0F43-4455-B061-453763790B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2938B-31E9-475E-8898-DE1692A28C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418BD-AA5E-495B-9332-2F449C7CC4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8A410-FAD4-4B7D-98C7-7D3EC7DC49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C1341-AA5E-4AAB-A356-D1A2A3011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8A185-5D87-4D7B-9237-6AD6D2192A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1FCC4D-FE72-4264-8E20-9E4B0203E924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239760" y="25560"/>
            <a:ext cx="8686800" cy="6774120"/>
            <a:chOff x="239760" y="25560"/>
            <a:chExt cx="8686800" cy="6774120"/>
          </a:xfrm>
        </p:grpSpPr>
        <p:grpSp>
          <p:nvGrpSpPr>
            <p:cNvPr id="42" name="Group 31"/>
            <p:cNvGrpSpPr/>
            <p:nvPr/>
          </p:nvGrpSpPr>
          <p:grpSpPr>
            <a:xfrm>
              <a:off x="239760" y="25560"/>
              <a:ext cx="8686800" cy="6661080"/>
              <a:chOff x="239760" y="25560"/>
              <a:chExt cx="8686800" cy="6661080"/>
            </a:xfrm>
          </p:grpSpPr>
          <p:pic>
            <p:nvPicPr>
              <p:cNvPr id="43" name="Chart 19" descr=""/>
              <p:cNvPicPr/>
              <p:nvPr/>
            </p:nvPicPr>
            <p:blipFill>
              <a:blip r:embed="rId1"/>
              <a:stretch/>
            </p:blipFill>
            <p:spPr>
              <a:xfrm>
                <a:off x="239760" y="25560"/>
                <a:ext cx="2322360" cy="2059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Chart 20" descr=""/>
              <p:cNvPicPr/>
              <p:nvPr/>
            </p:nvPicPr>
            <p:blipFill>
              <a:blip r:embed="rId2"/>
              <a:stretch/>
            </p:blipFill>
            <p:spPr>
              <a:xfrm>
                <a:off x="2562120" y="104760"/>
                <a:ext cx="2170080" cy="1980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Chart 21" descr=""/>
              <p:cNvPicPr/>
              <p:nvPr/>
            </p:nvPicPr>
            <p:blipFill>
              <a:blip r:embed="rId3"/>
              <a:stretch/>
            </p:blipFill>
            <p:spPr>
              <a:xfrm>
                <a:off x="4884840" y="104760"/>
                <a:ext cx="1944360" cy="1980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Chart 22" descr=""/>
              <p:cNvPicPr/>
              <p:nvPr/>
            </p:nvPicPr>
            <p:blipFill>
              <a:blip r:embed="rId4"/>
              <a:stretch/>
            </p:blipFill>
            <p:spPr>
              <a:xfrm>
                <a:off x="6829560" y="25560"/>
                <a:ext cx="2097000" cy="2059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Chart 23" descr=""/>
              <p:cNvPicPr/>
              <p:nvPr/>
            </p:nvPicPr>
            <p:blipFill>
              <a:blip r:embed="rId5"/>
              <a:stretch/>
            </p:blipFill>
            <p:spPr>
              <a:xfrm>
                <a:off x="312840" y="2164680"/>
                <a:ext cx="2237040" cy="2285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Chart 24" descr=""/>
              <p:cNvPicPr/>
              <p:nvPr/>
            </p:nvPicPr>
            <p:blipFill>
              <a:blip r:embed="rId6"/>
              <a:stretch/>
            </p:blipFill>
            <p:spPr>
              <a:xfrm>
                <a:off x="2635560" y="2085480"/>
                <a:ext cx="2023920" cy="2303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Chart 25" descr=""/>
              <p:cNvPicPr/>
              <p:nvPr/>
            </p:nvPicPr>
            <p:blipFill>
              <a:blip r:embed="rId7"/>
              <a:stretch/>
            </p:blipFill>
            <p:spPr>
              <a:xfrm>
                <a:off x="4732560" y="2085480"/>
                <a:ext cx="2023920" cy="2285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Chart 26" descr=""/>
              <p:cNvPicPr/>
              <p:nvPr/>
            </p:nvPicPr>
            <p:blipFill>
              <a:blip r:embed="rId8"/>
              <a:stretch/>
            </p:blipFill>
            <p:spPr>
              <a:xfrm>
                <a:off x="6829560" y="2085480"/>
                <a:ext cx="2023920" cy="2224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Chart 27" descr=""/>
              <p:cNvPicPr/>
              <p:nvPr/>
            </p:nvPicPr>
            <p:blipFill>
              <a:blip r:embed="rId9"/>
              <a:stretch/>
            </p:blipFill>
            <p:spPr>
              <a:xfrm>
                <a:off x="239760" y="4480560"/>
                <a:ext cx="2097000" cy="2126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Chart 28" descr=""/>
              <p:cNvPicPr/>
              <p:nvPr/>
            </p:nvPicPr>
            <p:blipFill>
              <a:blip r:embed="rId10"/>
              <a:stretch/>
            </p:blipFill>
            <p:spPr>
              <a:xfrm>
                <a:off x="2562120" y="4383000"/>
                <a:ext cx="2097000" cy="214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Chart 29" descr=""/>
              <p:cNvPicPr/>
              <p:nvPr/>
            </p:nvPicPr>
            <p:blipFill>
              <a:blip r:embed="rId11"/>
              <a:stretch/>
            </p:blipFill>
            <p:spPr>
              <a:xfrm>
                <a:off x="4659480" y="4309920"/>
                <a:ext cx="2097000" cy="2376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Chart 30" descr=""/>
              <p:cNvPicPr/>
              <p:nvPr/>
            </p:nvPicPr>
            <p:blipFill>
              <a:blip r:embed="rId12"/>
              <a:stretch/>
            </p:blipFill>
            <p:spPr>
              <a:xfrm>
                <a:off x="6756480" y="4383000"/>
                <a:ext cx="2170080" cy="21452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5" name="TextBox 1"/>
            <p:cNvSpPr/>
            <p:nvPr/>
          </p:nvSpPr>
          <p:spPr>
            <a:xfrm>
              <a:off x="315720" y="6523200"/>
              <a:ext cx="861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 S1. Various blood parameters in vaccinated- and unvaccinated animals at various times after vaccination.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5T05:47:36Z</dcterms:created>
  <dc:creator>naveen</dc:creator>
  <dc:description/>
  <dc:language>en-US</dc:language>
  <cp:lastModifiedBy>NCVTC</cp:lastModifiedBy>
  <cp:lastPrinted>2022-11-12T05:06:56Z</cp:lastPrinted>
  <dcterms:modified xsi:type="dcterms:W3CDTF">2022-12-10T07:00:56Z</dcterms:modified>
  <cp:revision>1409</cp:revision>
  <dc:subject/>
  <dc:title>Slide 1</dc:title>
</cp:coreProperties>
</file>